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55" autoAdjust="0"/>
    <p:restoredTop sz="94660"/>
  </p:normalViewPr>
  <p:slideViewPr>
    <p:cSldViewPr>
      <p:cViewPr varScale="1">
        <p:scale>
          <a:sx n="82" d="100"/>
          <a:sy n="82" d="100"/>
        </p:scale>
        <p:origin x="-1670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7808B7-AC23-4DC3-997F-D0378B24D325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7E64D9-6B14-4E37-9FEF-D9120E6DD8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65878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7E64D9-6B14-4E37-9FEF-D9120E6DD806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6314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76E1C-CD2E-4631-BDE5-548523F8951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C01A5-5E2B-4D94-B6D8-42875AA894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2248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76E1C-CD2E-4631-BDE5-548523F8951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C01A5-5E2B-4D94-B6D8-42875AA894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89593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76E1C-CD2E-4631-BDE5-548523F8951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C01A5-5E2B-4D94-B6D8-42875AA894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2016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76E1C-CD2E-4631-BDE5-548523F8951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C01A5-5E2B-4D94-B6D8-42875AA894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85023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76E1C-CD2E-4631-BDE5-548523F8951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C01A5-5E2B-4D94-B6D8-42875AA894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1499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76E1C-CD2E-4631-BDE5-548523F8951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C01A5-5E2B-4D94-B6D8-42875AA894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7921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76E1C-CD2E-4631-BDE5-548523F8951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C01A5-5E2B-4D94-B6D8-42875AA894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5125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76E1C-CD2E-4631-BDE5-548523F8951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C01A5-5E2B-4D94-B6D8-42875AA894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85285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76E1C-CD2E-4631-BDE5-548523F8951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C01A5-5E2B-4D94-B6D8-42875AA894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5494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76E1C-CD2E-4631-BDE5-548523F8951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C01A5-5E2B-4D94-B6D8-42875AA894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78410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376E1C-CD2E-4631-BDE5-548523F8951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C01A5-5E2B-4D94-B6D8-42875AA894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65092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376E1C-CD2E-4631-BDE5-548523F8951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BC01A5-5E2B-4D94-B6D8-42875AA894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6618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png"/><Relationship Id="rId18" Type="http://schemas.openxmlformats.org/officeDocument/2006/relationships/image" Target="../media/image22.jp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12" Type="http://schemas.openxmlformats.org/officeDocument/2006/relationships/image" Target="../media/image16.png"/><Relationship Id="rId17" Type="http://schemas.openxmlformats.org/officeDocument/2006/relationships/image" Target="../media/image21.jpg"/><Relationship Id="rId2" Type="http://schemas.openxmlformats.org/officeDocument/2006/relationships/image" Target="../media/image6.png"/><Relationship Id="rId16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11" Type="http://schemas.openxmlformats.org/officeDocument/2006/relationships/image" Target="../media/image15.jpg"/><Relationship Id="rId5" Type="http://schemas.openxmlformats.org/officeDocument/2006/relationships/image" Target="../media/image9.png"/><Relationship Id="rId15" Type="http://schemas.openxmlformats.org/officeDocument/2006/relationships/image" Target="../media/image19.png"/><Relationship Id="rId10" Type="http://schemas.openxmlformats.org/officeDocument/2006/relationships/image" Target="../media/image14.png"/><Relationship Id="rId19" Type="http://schemas.openxmlformats.org/officeDocument/2006/relationships/image" Target="../media/image23.png"/><Relationship Id="rId4" Type="http://schemas.openxmlformats.org/officeDocument/2006/relationships/image" Target="../media/image8.png"/><Relationship Id="rId9" Type="http://schemas.openxmlformats.org/officeDocument/2006/relationships/image" Target="../media/image13.png"/><Relationship Id="rId14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openxmlformats.org/officeDocument/2006/relationships/image" Target="../media/image35.png"/><Relationship Id="rId18" Type="http://schemas.openxmlformats.org/officeDocument/2006/relationships/image" Target="../media/image40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12" Type="http://schemas.openxmlformats.org/officeDocument/2006/relationships/image" Target="../media/image34.png"/><Relationship Id="rId17" Type="http://schemas.openxmlformats.org/officeDocument/2006/relationships/image" Target="../media/image39.png"/><Relationship Id="rId2" Type="http://schemas.openxmlformats.org/officeDocument/2006/relationships/image" Target="../media/image24.png"/><Relationship Id="rId16" Type="http://schemas.openxmlformats.org/officeDocument/2006/relationships/image" Target="../media/image3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11" Type="http://schemas.openxmlformats.org/officeDocument/2006/relationships/image" Target="../media/image33.png"/><Relationship Id="rId5" Type="http://schemas.openxmlformats.org/officeDocument/2006/relationships/image" Target="../media/image27.png"/><Relationship Id="rId15" Type="http://schemas.openxmlformats.org/officeDocument/2006/relationships/image" Target="../media/image37.png"/><Relationship Id="rId10" Type="http://schemas.openxmlformats.org/officeDocument/2006/relationships/image" Target="../media/image32.png"/><Relationship Id="rId4" Type="http://schemas.openxmlformats.org/officeDocument/2006/relationships/image" Target="../media/image26.png"/><Relationship Id="rId9" Type="http://schemas.openxmlformats.org/officeDocument/2006/relationships/image" Target="../media/image31.png"/><Relationship Id="rId14" Type="http://schemas.openxmlformats.org/officeDocument/2006/relationships/image" Target="../media/image3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png"/><Relationship Id="rId13" Type="http://schemas.openxmlformats.org/officeDocument/2006/relationships/image" Target="../media/image51.png"/><Relationship Id="rId3" Type="http://schemas.openxmlformats.org/officeDocument/2006/relationships/image" Target="../media/image41.jpeg"/><Relationship Id="rId7" Type="http://schemas.openxmlformats.org/officeDocument/2006/relationships/image" Target="../media/image45.jpeg"/><Relationship Id="rId12" Type="http://schemas.openxmlformats.org/officeDocument/2006/relationships/image" Target="../media/image5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4.jpeg"/><Relationship Id="rId11" Type="http://schemas.openxmlformats.org/officeDocument/2006/relationships/image" Target="../media/image49.png"/><Relationship Id="rId5" Type="http://schemas.openxmlformats.org/officeDocument/2006/relationships/image" Target="../media/image43.jpeg"/><Relationship Id="rId10" Type="http://schemas.openxmlformats.org/officeDocument/2006/relationships/image" Target="../media/image48.png"/><Relationship Id="rId4" Type="http://schemas.openxmlformats.org/officeDocument/2006/relationships/image" Target="../media/image42.jpeg"/><Relationship Id="rId9" Type="http://schemas.openxmlformats.org/officeDocument/2006/relationships/image" Target="../media/image47.jpeg"/><Relationship Id="rId14" Type="http://schemas.openxmlformats.org/officeDocument/2006/relationships/image" Target="../media/image5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1729B083-01CC-AA9B-9D9B-A2EC4A7C6E6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2694" y="950095"/>
            <a:ext cx="4065729" cy="2548128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96A6CC71-795C-433F-D16C-5EBE94461A0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8718" y="947918"/>
            <a:ext cx="3762778" cy="2538984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xmlns="" id="{459681C3-CDDA-1E21-B683-B00B80AE0F7E}"/>
              </a:ext>
            </a:extLst>
          </p:cNvPr>
          <p:cNvSpPr txBox="1"/>
          <p:nvPr/>
        </p:nvSpPr>
        <p:spPr>
          <a:xfrm>
            <a:off x="8100392" y="6453336"/>
            <a:ext cx="96666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 Fig. 1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xmlns="" id="{719AE4C9-2858-48D2-2954-60C92601BB9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0780" y="3751674"/>
            <a:ext cx="3217644" cy="2538984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xmlns="" id="{0269E035-C19E-F3C8-2EB5-04CE6F6C385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3740" y="3761281"/>
            <a:ext cx="3027756" cy="2538984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xmlns="" id="{B80522AC-16CB-EE2E-F531-98538C0AFAD1}"/>
              </a:ext>
            </a:extLst>
          </p:cNvPr>
          <p:cNvSpPr txBox="1"/>
          <p:nvPr/>
        </p:nvSpPr>
        <p:spPr>
          <a:xfrm flipH="1">
            <a:off x="1136341" y="902332"/>
            <a:ext cx="224257" cy="3664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xmlns="" id="{CD9D6640-391E-CB12-E361-36F487E17BA7}"/>
              </a:ext>
            </a:extLst>
          </p:cNvPr>
          <p:cNvSpPr txBox="1"/>
          <p:nvPr/>
        </p:nvSpPr>
        <p:spPr>
          <a:xfrm flipH="1">
            <a:off x="4754743" y="902332"/>
            <a:ext cx="224257" cy="3664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xmlns="" id="{D4038EBC-CB60-5437-0260-095D0607847D}"/>
              </a:ext>
            </a:extLst>
          </p:cNvPr>
          <p:cNvSpPr txBox="1"/>
          <p:nvPr/>
        </p:nvSpPr>
        <p:spPr>
          <a:xfrm flipH="1">
            <a:off x="1128109" y="3710644"/>
            <a:ext cx="224257" cy="3664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xmlns="" id="{40B0D41E-A32F-0231-F1A5-7DDC6A509931}"/>
              </a:ext>
            </a:extLst>
          </p:cNvPr>
          <p:cNvSpPr txBox="1"/>
          <p:nvPr/>
        </p:nvSpPr>
        <p:spPr>
          <a:xfrm flipH="1">
            <a:off x="4754743" y="3710644"/>
            <a:ext cx="224257" cy="3664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50044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xmlns="" id="{ACA6409D-FE7D-C96B-E37F-30C8125CF6B5}"/>
              </a:ext>
            </a:extLst>
          </p:cNvPr>
          <p:cNvGrpSpPr/>
          <p:nvPr/>
        </p:nvGrpSpPr>
        <p:grpSpPr>
          <a:xfrm>
            <a:off x="2789802" y="1772817"/>
            <a:ext cx="4482498" cy="2878579"/>
            <a:chOff x="767408" y="1340768"/>
            <a:chExt cx="5976664" cy="2878579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xmlns="" id="{9BFCE8E9-2C4E-9A00-4DED-80B18F10A4E8}"/>
                </a:ext>
              </a:extLst>
            </p:cNvPr>
            <p:cNvSpPr txBox="1"/>
            <p:nvPr/>
          </p:nvSpPr>
          <p:spPr>
            <a:xfrm>
              <a:off x="767408" y="3573016"/>
              <a:ext cx="597666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prosertib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-      -      -     +     +    + </a:t>
              </a:r>
            </a:p>
            <a:p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enkyunolide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A  -      +     -      -     +     - </a:t>
              </a:r>
            </a:p>
            <a:p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opoletin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-      -     +      -     -     +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" name="图片 6">
              <a:extLst>
                <a:ext uri="{FF2B5EF4-FFF2-40B4-BE49-F238E27FC236}">
                  <a16:creationId xmlns:a16="http://schemas.microsoft.com/office/drawing/2014/main" xmlns="" id="{A287076F-1123-E781-4C64-0B5C1451113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15480" y="1340768"/>
              <a:ext cx="3504389" cy="2292096"/>
            </a:xfrm>
            <a:prstGeom prst="rect">
              <a:avLst/>
            </a:prstGeom>
          </p:spPr>
        </p:pic>
      </p:grpSp>
      <p:sp>
        <p:nvSpPr>
          <p:cNvPr id="6" name="文本框 9">
            <a:extLst>
              <a:ext uri="{FF2B5EF4-FFF2-40B4-BE49-F238E27FC236}">
                <a16:creationId xmlns:a16="http://schemas.microsoft.com/office/drawing/2014/main" xmlns="" id="{459681C3-CDDA-1E21-B683-B00B80AE0F7E}"/>
              </a:ext>
            </a:extLst>
          </p:cNvPr>
          <p:cNvSpPr txBox="1"/>
          <p:nvPr/>
        </p:nvSpPr>
        <p:spPr>
          <a:xfrm>
            <a:off x="8100392" y="6453336"/>
            <a:ext cx="96666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 Fig. 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3260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568343B7-BCD5-31C6-ADD5-1A1E5CF5F9BE}"/>
              </a:ext>
            </a:extLst>
          </p:cNvPr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28" b="1540"/>
          <a:stretch/>
        </p:blipFill>
        <p:spPr>
          <a:xfrm>
            <a:off x="1923743" y="2327328"/>
            <a:ext cx="1803600" cy="4536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BEC902A7-C115-7D31-D35B-7FA4E4EFADFB}"/>
              </a:ext>
            </a:extLst>
          </p:cNvPr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0" b="3322"/>
          <a:stretch/>
        </p:blipFill>
        <p:spPr>
          <a:xfrm>
            <a:off x="1909504" y="4370940"/>
            <a:ext cx="1803600" cy="4536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377F9F2D-65E3-8A55-E919-F95EF0DECF96}"/>
              </a:ext>
            </a:extLst>
          </p:cNvPr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4" b="3322"/>
          <a:stretch/>
        </p:blipFill>
        <p:spPr>
          <a:xfrm>
            <a:off x="1917781" y="2898508"/>
            <a:ext cx="1803600" cy="4536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4917A5FC-A0F0-C0A7-4102-8788F2C27355}"/>
              </a:ext>
            </a:extLst>
          </p:cNvPr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631"/>
          <a:stretch/>
        </p:blipFill>
        <p:spPr>
          <a:xfrm>
            <a:off x="1937767" y="1739927"/>
            <a:ext cx="1803600" cy="45360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FBF4EF71-7E27-80AC-33BC-94637DAE80B7}"/>
              </a:ext>
            </a:extLst>
          </p:cNvPr>
          <p:cNvSpPr txBox="1"/>
          <p:nvPr/>
        </p:nvSpPr>
        <p:spPr>
          <a:xfrm>
            <a:off x="611779" y="5007417"/>
            <a:ext cx="8186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xmlns="" id="{ECE8D731-7830-5FCA-EFB7-67234F9DA9FF}"/>
              </a:ext>
            </a:extLst>
          </p:cNvPr>
          <p:cNvSpPr txBox="1"/>
          <p:nvPr/>
        </p:nvSpPr>
        <p:spPr>
          <a:xfrm>
            <a:off x="611779" y="3953708"/>
            <a:ext cx="9081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xmlns="" id="{DDCEF6B1-31B0-85D6-E83D-5B8C63846F43}"/>
              </a:ext>
            </a:extLst>
          </p:cNvPr>
          <p:cNvSpPr txBox="1"/>
          <p:nvPr/>
        </p:nvSpPr>
        <p:spPr>
          <a:xfrm>
            <a:off x="611779" y="4451095"/>
            <a:ext cx="7900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xmlns="" id="{29B078C9-9173-B740-77D2-049DEBCAC4EC}"/>
              </a:ext>
            </a:extLst>
          </p:cNvPr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9504" y="3839496"/>
            <a:ext cx="1803600" cy="453600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xmlns="" id="{D0C5EE32-A04F-39C8-8CDD-FC4E295C1E14}"/>
              </a:ext>
            </a:extLst>
          </p:cNvPr>
          <p:cNvSpPr txBox="1"/>
          <p:nvPr/>
        </p:nvSpPr>
        <p:spPr>
          <a:xfrm>
            <a:off x="2256445" y="1187460"/>
            <a:ext cx="871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repeat1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xmlns="" id="{31516862-32C0-397C-46EF-3A7F4A2E7E48}"/>
              </a:ext>
            </a:extLst>
          </p:cNvPr>
          <p:cNvSpPr txBox="1"/>
          <p:nvPr/>
        </p:nvSpPr>
        <p:spPr>
          <a:xfrm>
            <a:off x="4637073" y="1187460"/>
            <a:ext cx="871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repeat2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xmlns="" id="{26B03474-8314-89D6-33F8-9EC64FE6D174}"/>
              </a:ext>
            </a:extLst>
          </p:cNvPr>
          <p:cNvSpPr txBox="1"/>
          <p:nvPr/>
        </p:nvSpPr>
        <p:spPr>
          <a:xfrm>
            <a:off x="6756352" y="1187460"/>
            <a:ext cx="871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repeat3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xmlns="" id="{F843FD95-2247-BA55-2330-7674B8637CCE}"/>
              </a:ext>
            </a:extLst>
          </p:cNvPr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26" t="20769" b="5914"/>
          <a:stretch/>
        </p:blipFill>
        <p:spPr>
          <a:xfrm>
            <a:off x="4126204" y="4370940"/>
            <a:ext cx="1803600" cy="4536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xmlns="" id="{6E3947E9-295B-BDC8-A865-C1B4D8745DE1}"/>
              </a:ext>
            </a:extLst>
          </p:cNvPr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16" t="-1" b="-2885"/>
          <a:stretch/>
        </p:blipFill>
        <p:spPr>
          <a:xfrm>
            <a:off x="4170015" y="2327328"/>
            <a:ext cx="1803600" cy="45360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xmlns="" id="{5A18D7A3-5F48-58FD-456A-9A05405B118C}"/>
              </a:ext>
            </a:extLst>
          </p:cNvPr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9580" y="3839496"/>
            <a:ext cx="1803600" cy="4536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xmlns="" id="{9A1C9098-D578-B64F-A08A-CA0E23D3E075}"/>
              </a:ext>
            </a:extLst>
          </p:cNvPr>
          <p:cNvPicPr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21" b="-1726"/>
          <a:stretch/>
        </p:blipFill>
        <p:spPr>
          <a:xfrm>
            <a:off x="4170015" y="1739927"/>
            <a:ext cx="1803600" cy="453600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xmlns="" id="{CEB259CD-090E-A809-D8C3-5F4283524468}"/>
              </a:ext>
            </a:extLst>
          </p:cNvPr>
          <p:cNvPicPr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77" t="39805" r="21603" b="48864"/>
          <a:stretch/>
        </p:blipFill>
        <p:spPr>
          <a:xfrm>
            <a:off x="4143655" y="2898508"/>
            <a:ext cx="1803600" cy="45360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xmlns="" id="{21034A78-541C-3054-F305-4D5117224660}"/>
              </a:ext>
            </a:extLst>
          </p:cNvPr>
          <p:cNvPicPr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6792" y="2898508"/>
            <a:ext cx="1803600" cy="45360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xmlns="" id="{1092A035-EDC7-5FB9-EE4C-B2297D49C207}"/>
              </a:ext>
            </a:extLst>
          </p:cNvPr>
          <p:cNvPicPr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46" t="22231" r="8051" b="4568"/>
          <a:stretch/>
        </p:blipFill>
        <p:spPr>
          <a:xfrm>
            <a:off x="6290525" y="4370940"/>
            <a:ext cx="1803600" cy="45360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xmlns="" id="{E2D49F90-BABB-C17C-AB1C-E4321C52CAB4}"/>
              </a:ext>
            </a:extLst>
          </p:cNvPr>
          <p:cNvPicPr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72" r="5394"/>
          <a:stretch/>
        </p:blipFill>
        <p:spPr>
          <a:xfrm>
            <a:off x="6296792" y="2327328"/>
            <a:ext cx="1803600" cy="45360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xmlns="" id="{1A899D0A-7B9B-F7AC-1FF8-3AB394585F00}"/>
              </a:ext>
            </a:extLst>
          </p:cNvPr>
          <p:cNvPicPr>
            <a:picLocks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8" r="8076" b="8736"/>
          <a:stretch/>
        </p:blipFill>
        <p:spPr>
          <a:xfrm>
            <a:off x="6290525" y="3839496"/>
            <a:ext cx="1803600" cy="453600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xmlns="" id="{BFFA3AC3-A4CC-DD29-A38E-016B3ECB0A1E}"/>
              </a:ext>
            </a:extLst>
          </p:cNvPr>
          <p:cNvPicPr>
            <a:picLocks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0525" y="1739927"/>
            <a:ext cx="1803600" cy="453600"/>
          </a:xfrm>
          <a:prstGeom prst="rect">
            <a:avLst/>
          </a:prstGeom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xmlns="" id="{1C55CF74-B6DC-531D-037A-A4CA46E6A0B7}"/>
              </a:ext>
            </a:extLst>
          </p:cNvPr>
          <p:cNvSpPr txBox="1"/>
          <p:nvPr/>
        </p:nvSpPr>
        <p:spPr>
          <a:xfrm>
            <a:off x="1385961" y="2413237"/>
            <a:ext cx="39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xmlns="" id="{6013C71A-23B0-5F4D-B04A-49F368CD0184}"/>
              </a:ext>
            </a:extLst>
          </p:cNvPr>
          <p:cNvSpPr txBox="1"/>
          <p:nvPr/>
        </p:nvSpPr>
        <p:spPr>
          <a:xfrm>
            <a:off x="1390184" y="2605715"/>
            <a:ext cx="389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xmlns="" id="{F9526BB4-78A5-CBF2-4EA5-FA9957A75F74}"/>
              </a:ext>
            </a:extLst>
          </p:cNvPr>
          <p:cNvSpPr txBox="1"/>
          <p:nvPr/>
        </p:nvSpPr>
        <p:spPr>
          <a:xfrm>
            <a:off x="1320210" y="1695004"/>
            <a:ext cx="4593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05E17D65-6B0F-D53E-2E84-E04355EE5C27}"/>
              </a:ext>
            </a:extLst>
          </p:cNvPr>
          <p:cNvSpPr txBox="1"/>
          <p:nvPr/>
        </p:nvSpPr>
        <p:spPr>
          <a:xfrm>
            <a:off x="1347539" y="2034369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xmlns="" id="{53C33C54-0B38-D769-2F42-1232E32B9EBE}"/>
              </a:ext>
            </a:extLst>
          </p:cNvPr>
          <p:cNvSpPr txBox="1"/>
          <p:nvPr/>
        </p:nvSpPr>
        <p:spPr>
          <a:xfrm>
            <a:off x="1347539" y="1876809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xmlns="" id="{F3CC4B9B-B0E0-E3B0-C977-29B8FF9EFA72}"/>
              </a:ext>
            </a:extLst>
          </p:cNvPr>
          <p:cNvSpPr txBox="1"/>
          <p:nvPr/>
        </p:nvSpPr>
        <p:spPr>
          <a:xfrm>
            <a:off x="1374372" y="3033768"/>
            <a:ext cx="4052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2" name="图片 41">
            <a:extLst>
              <a:ext uri="{FF2B5EF4-FFF2-40B4-BE49-F238E27FC236}">
                <a16:creationId xmlns:a16="http://schemas.microsoft.com/office/drawing/2014/main" xmlns="" id="{96093B0A-03E4-971D-1477-C96D2F4960CF}"/>
              </a:ext>
            </a:extLst>
          </p:cNvPr>
          <p:cNvPicPr>
            <a:picLocks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76" t="41519" r="24728" b="46245"/>
          <a:stretch/>
        </p:blipFill>
        <p:spPr>
          <a:xfrm>
            <a:off x="1917781" y="4870316"/>
            <a:ext cx="1803600" cy="453600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xmlns="" id="{FF16EFAE-E1A6-B70C-812F-D1BC1D098FEE}"/>
              </a:ext>
            </a:extLst>
          </p:cNvPr>
          <p:cNvPicPr>
            <a:picLocks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37" t="42612" r="19783" b="44833"/>
          <a:stretch/>
        </p:blipFill>
        <p:spPr>
          <a:xfrm>
            <a:off x="4109580" y="4870316"/>
            <a:ext cx="1803600" cy="453600"/>
          </a:xfrm>
          <a:prstGeom prst="rect">
            <a:avLst/>
          </a:pr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xmlns="" id="{F2DDAAB0-BFA2-895A-2556-200FF9BF315A}"/>
              </a:ext>
            </a:extLst>
          </p:cNvPr>
          <p:cNvPicPr>
            <a:picLocks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450" b="-11934"/>
          <a:stretch/>
        </p:blipFill>
        <p:spPr>
          <a:xfrm>
            <a:off x="6290525" y="4870316"/>
            <a:ext cx="1803600" cy="453600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xmlns="" id="{675FF6FA-7807-7B8E-CD99-E8934A20276F}"/>
              </a:ext>
            </a:extLst>
          </p:cNvPr>
          <p:cNvSpPr txBox="1"/>
          <p:nvPr/>
        </p:nvSpPr>
        <p:spPr>
          <a:xfrm>
            <a:off x="1312179" y="548680"/>
            <a:ext cx="6788213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presentative original images of western blots for Figure 6A.</a:t>
            </a:r>
            <a:endParaRPr lang="zh-CN" altLang="zh-CN" sz="14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xmlns="" id="{60235D73-0463-E796-EAB2-DF185EBD2500}"/>
              </a:ext>
            </a:extLst>
          </p:cNvPr>
          <p:cNvCxnSpPr>
            <a:cxnSpLocks/>
          </p:cNvCxnSpPr>
          <p:nvPr/>
        </p:nvCxnSpPr>
        <p:spPr>
          <a:xfrm>
            <a:off x="1714226" y="1854190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xmlns="" id="{E8FABD0A-E896-2379-2522-79220664ABE7}"/>
              </a:ext>
            </a:extLst>
          </p:cNvPr>
          <p:cNvCxnSpPr>
            <a:cxnSpLocks/>
          </p:cNvCxnSpPr>
          <p:nvPr/>
        </p:nvCxnSpPr>
        <p:spPr>
          <a:xfrm>
            <a:off x="1714226" y="1993397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xmlns="" id="{E5945691-6664-5380-2FA3-01FF6EE6C019}"/>
              </a:ext>
            </a:extLst>
          </p:cNvPr>
          <p:cNvCxnSpPr>
            <a:cxnSpLocks/>
          </p:cNvCxnSpPr>
          <p:nvPr/>
        </p:nvCxnSpPr>
        <p:spPr>
          <a:xfrm>
            <a:off x="1714226" y="2153808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xmlns="" id="{F065DD19-C59E-E532-A4C7-0BB62E8DF4F8}"/>
              </a:ext>
            </a:extLst>
          </p:cNvPr>
          <p:cNvCxnSpPr>
            <a:cxnSpLocks/>
          </p:cNvCxnSpPr>
          <p:nvPr/>
        </p:nvCxnSpPr>
        <p:spPr>
          <a:xfrm>
            <a:off x="1714226" y="2554764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xmlns="" id="{E9524257-987B-C3FD-601F-590F9EDE0720}"/>
              </a:ext>
            </a:extLst>
          </p:cNvPr>
          <p:cNvCxnSpPr>
            <a:cxnSpLocks/>
          </p:cNvCxnSpPr>
          <p:nvPr/>
        </p:nvCxnSpPr>
        <p:spPr>
          <a:xfrm>
            <a:off x="1714226" y="2742998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xmlns="" id="{5A91BD06-FB11-6471-E5B4-E437E0BCACAC}"/>
              </a:ext>
            </a:extLst>
          </p:cNvPr>
          <p:cNvCxnSpPr>
            <a:cxnSpLocks/>
          </p:cNvCxnSpPr>
          <p:nvPr/>
        </p:nvCxnSpPr>
        <p:spPr>
          <a:xfrm>
            <a:off x="1714226" y="3180392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xmlns="" id="{F429B75A-B955-1F3C-C3AB-A7C2CF233110}"/>
              </a:ext>
            </a:extLst>
          </p:cNvPr>
          <p:cNvSpPr txBox="1"/>
          <p:nvPr/>
        </p:nvSpPr>
        <p:spPr>
          <a:xfrm>
            <a:off x="611779" y="1841663"/>
            <a:ext cx="8172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p-eNOS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xmlns="" id="{2B1C2E12-6D3E-90A2-5B7E-A0199AF29FEC}"/>
              </a:ext>
            </a:extLst>
          </p:cNvPr>
          <p:cNvSpPr txBox="1"/>
          <p:nvPr/>
        </p:nvSpPr>
        <p:spPr>
          <a:xfrm>
            <a:off x="611779" y="2406425"/>
            <a:ext cx="631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p-AKT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xmlns="" id="{3986E13F-64BF-DE9E-B7FF-6094047C223F}"/>
              </a:ext>
            </a:extLst>
          </p:cNvPr>
          <p:cNvSpPr txBox="1"/>
          <p:nvPr/>
        </p:nvSpPr>
        <p:spPr>
          <a:xfrm>
            <a:off x="611779" y="3055500"/>
            <a:ext cx="8361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xmlns="" id="{7A4E157B-602B-A634-3DB0-5F68206551AD}"/>
              </a:ext>
            </a:extLst>
          </p:cNvPr>
          <p:cNvSpPr txBox="1"/>
          <p:nvPr/>
        </p:nvSpPr>
        <p:spPr>
          <a:xfrm>
            <a:off x="1374484" y="4424200"/>
            <a:ext cx="39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xmlns="" id="{C0419E90-2FD7-B8A3-4D3F-857DE1F572CA}"/>
              </a:ext>
            </a:extLst>
          </p:cNvPr>
          <p:cNvSpPr txBox="1"/>
          <p:nvPr/>
        </p:nvSpPr>
        <p:spPr>
          <a:xfrm>
            <a:off x="1378707" y="4603483"/>
            <a:ext cx="389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xmlns="" id="{650F836B-5154-2C15-22A2-279C4A2D847B}"/>
              </a:ext>
            </a:extLst>
          </p:cNvPr>
          <p:cNvSpPr txBox="1"/>
          <p:nvPr/>
        </p:nvSpPr>
        <p:spPr>
          <a:xfrm>
            <a:off x="1308733" y="3844279"/>
            <a:ext cx="4593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xmlns="" id="{81D21763-1715-9931-056B-A1592C3AFAF2}"/>
              </a:ext>
            </a:extLst>
          </p:cNvPr>
          <p:cNvSpPr txBox="1"/>
          <p:nvPr/>
        </p:nvSpPr>
        <p:spPr>
          <a:xfrm>
            <a:off x="1336062" y="4183644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xmlns="" id="{77B8272C-00CE-BB89-8B72-E14354601BD0}"/>
              </a:ext>
            </a:extLst>
          </p:cNvPr>
          <p:cNvSpPr txBox="1"/>
          <p:nvPr/>
        </p:nvSpPr>
        <p:spPr>
          <a:xfrm>
            <a:off x="1336062" y="4026084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xmlns="" id="{7631A4D1-40FE-AF39-0E69-DE0D4A273018}"/>
              </a:ext>
            </a:extLst>
          </p:cNvPr>
          <p:cNvSpPr txBox="1"/>
          <p:nvPr/>
        </p:nvSpPr>
        <p:spPr>
          <a:xfrm>
            <a:off x="1362895" y="5056043"/>
            <a:ext cx="4052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xmlns="" id="{2158D366-7A0E-1CAC-1ED7-47DE4B89FE82}"/>
              </a:ext>
            </a:extLst>
          </p:cNvPr>
          <p:cNvCxnSpPr>
            <a:cxnSpLocks/>
          </p:cNvCxnSpPr>
          <p:nvPr/>
        </p:nvCxnSpPr>
        <p:spPr>
          <a:xfrm>
            <a:off x="1714226" y="4003465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xmlns="" id="{60538A9A-6410-EF57-D99B-D366CEBA80A9}"/>
              </a:ext>
            </a:extLst>
          </p:cNvPr>
          <p:cNvCxnSpPr>
            <a:cxnSpLocks/>
          </p:cNvCxnSpPr>
          <p:nvPr/>
        </p:nvCxnSpPr>
        <p:spPr>
          <a:xfrm>
            <a:off x="1714226" y="4142672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xmlns="" id="{22C3DEF4-DCD4-202A-09FC-8E959633F0A0}"/>
              </a:ext>
            </a:extLst>
          </p:cNvPr>
          <p:cNvCxnSpPr>
            <a:cxnSpLocks/>
          </p:cNvCxnSpPr>
          <p:nvPr/>
        </p:nvCxnSpPr>
        <p:spPr>
          <a:xfrm>
            <a:off x="1714226" y="4303083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xmlns="" id="{BCAB3335-E471-0F09-6899-C50B5546C73D}"/>
              </a:ext>
            </a:extLst>
          </p:cNvPr>
          <p:cNvCxnSpPr>
            <a:cxnSpLocks/>
          </p:cNvCxnSpPr>
          <p:nvPr/>
        </p:nvCxnSpPr>
        <p:spPr>
          <a:xfrm>
            <a:off x="1714226" y="5183043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xmlns="" id="{6D2F6360-3472-2686-17E0-20F9E4C36DF3}"/>
              </a:ext>
            </a:extLst>
          </p:cNvPr>
          <p:cNvCxnSpPr>
            <a:cxnSpLocks/>
          </p:cNvCxnSpPr>
          <p:nvPr/>
        </p:nvCxnSpPr>
        <p:spPr>
          <a:xfrm>
            <a:off x="1714226" y="4562512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xmlns="" id="{8CAA9FBA-B8F1-5B09-8C57-C5A406C2FF78}"/>
              </a:ext>
            </a:extLst>
          </p:cNvPr>
          <p:cNvCxnSpPr>
            <a:cxnSpLocks/>
          </p:cNvCxnSpPr>
          <p:nvPr/>
        </p:nvCxnSpPr>
        <p:spPr>
          <a:xfrm>
            <a:off x="1714226" y="4728094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242929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xmlns="" id="{3026206E-D7C1-0514-33DC-443AC2A17197}"/>
              </a:ext>
            </a:extLst>
          </p:cNvPr>
          <p:cNvSpPr txBox="1"/>
          <p:nvPr/>
        </p:nvSpPr>
        <p:spPr>
          <a:xfrm>
            <a:off x="6940414" y="1475492"/>
            <a:ext cx="871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repeat3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xmlns="" id="{FF2FE884-9B95-97AB-9C57-F874C34DDF1F}"/>
              </a:ext>
            </a:extLst>
          </p:cNvPr>
          <p:cNvSpPr txBox="1"/>
          <p:nvPr/>
        </p:nvSpPr>
        <p:spPr>
          <a:xfrm>
            <a:off x="2979974" y="1547500"/>
            <a:ext cx="871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repeat1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xmlns="" id="{7E5A60EF-A464-9E42-E5AC-B724A8691673}"/>
              </a:ext>
            </a:extLst>
          </p:cNvPr>
          <p:cNvSpPr txBox="1"/>
          <p:nvPr/>
        </p:nvSpPr>
        <p:spPr>
          <a:xfrm>
            <a:off x="4999613" y="1475492"/>
            <a:ext cx="871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repeat2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xmlns="" id="{DCA4D267-1261-E50A-44BA-D56374979B06}"/>
              </a:ext>
            </a:extLst>
          </p:cNvPr>
          <p:cNvSpPr txBox="1"/>
          <p:nvPr/>
        </p:nvSpPr>
        <p:spPr>
          <a:xfrm>
            <a:off x="1043608" y="5336704"/>
            <a:ext cx="824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xmlns="" id="{7AAA6BE7-08BE-EC66-DC08-2524ED0B57A8}"/>
              </a:ext>
            </a:extLst>
          </p:cNvPr>
          <p:cNvSpPr txBox="1"/>
          <p:nvPr/>
        </p:nvSpPr>
        <p:spPr>
          <a:xfrm>
            <a:off x="1102165" y="4149080"/>
            <a:ext cx="6067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xmlns="" id="{06EF3E08-CB3D-09DB-9976-B65C74CCF221}"/>
              </a:ext>
            </a:extLst>
          </p:cNvPr>
          <p:cNvSpPr txBox="1"/>
          <p:nvPr/>
        </p:nvSpPr>
        <p:spPr>
          <a:xfrm>
            <a:off x="1077644" y="2032162"/>
            <a:ext cx="8172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p-eNOS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xmlns="" id="{63AC3E1F-6B88-287C-0F18-CBC8F9B1AADD}"/>
              </a:ext>
            </a:extLst>
          </p:cNvPr>
          <p:cNvSpPr txBox="1"/>
          <p:nvPr/>
        </p:nvSpPr>
        <p:spPr>
          <a:xfrm>
            <a:off x="1077644" y="2651358"/>
            <a:ext cx="631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p-AKT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xmlns="" id="{14781FC0-DC33-0C16-D869-C928A2E83FCE}"/>
              </a:ext>
            </a:extLst>
          </p:cNvPr>
          <p:cNvSpPr txBox="1"/>
          <p:nvPr/>
        </p:nvSpPr>
        <p:spPr>
          <a:xfrm>
            <a:off x="1077644" y="4705380"/>
            <a:ext cx="5006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3FB5B071-F486-9257-F3CC-C7F17F4324AF}"/>
              </a:ext>
            </a:extLst>
          </p:cNvPr>
          <p:cNvSpPr txBox="1"/>
          <p:nvPr/>
        </p:nvSpPr>
        <p:spPr>
          <a:xfrm>
            <a:off x="1087509" y="3212976"/>
            <a:ext cx="722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xmlns="" id="{40285A3E-F04D-E993-5A15-46663B04A675}"/>
              </a:ext>
            </a:extLst>
          </p:cNvPr>
          <p:cNvSpPr txBox="1"/>
          <p:nvPr/>
        </p:nvSpPr>
        <p:spPr>
          <a:xfrm>
            <a:off x="1694511" y="692696"/>
            <a:ext cx="6318702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presentative original images of western blots for Figure 6B.</a:t>
            </a:r>
            <a:endParaRPr lang="zh-CN" altLang="zh-CN" sz="14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6" name="文本框 30">
            <a:extLst>
              <a:ext uri="{FF2B5EF4-FFF2-40B4-BE49-F238E27FC236}">
                <a16:creationId xmlns:a16="http://schemas.microsoft.com/office/drawing/2014/main" xmlns="" id="{1C55CF74-B6DC-531D-037A-A4CA46E6A0B7}"/>
              </a:ext>
            </a:extLst>
          </p:cNvPr>
          <p:cNvSpPr txBox="1"/>
          <p:nvPr/>
        </p:nvSpPr>
        <p:spPr>
          <a:xfrm>
            <a:off x="1972435" y="2518030"/>
            <a:ext cx="3745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7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1">
            <a:extLst>
              <a:ext uri="{FF2B5EF4-FFF2-40B4-BE49-F238E27FC236}">
                <a16:creationId xmlns:a16="http://schemas.microsoft.com/office/drawing/2014/main" xmlns="" id="{6013C71A-23B0-5F4D-B04A-49F368CD0184}"/>
              </a:ext>
            </a:extLst>
          </p:cNvPr>
          <p:cNvSpPr txBox="1"/>
          <p:nvPr/>
        </p:nvSpPr>
        <p:spPr>
          <a:xfrm>
            <a:off x="1972435" y="2751115"/>
            <a:ext cx="3745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5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1">
            <a:extLst>
              <a:ext uri="{FF2B5EF4-FFF2-40B4-BE49-F238E27FC236}">
                <a16:creationId xmlns:a16="http://schemas.microsoft.com/office/drawing/2014/main" xmlns="" id="{F9526BB4-78A5-CBF2-4EA5-FA9957A75F74}"/>
              </a:ext>
            </a:extLst>
          </p:cNvPr>
          <p:cNvSpPr txBox="1"/>
          <p:nvPr/>
        </p:nvSpPr>
        <p:spPr>
          <a:xfrm>
            <a:off x="1948385" y="1903627"/>
            <a:ext cx="5087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2">
            <a:extLst>
              <a:ext uri="{FF2B5EF4-FFF2-40B4-BE49-F238E27FC236}">
                <a16:creationId xmlns:a16="http://schemas.microsoft.com/office/drawing/2014/main" xmlns="" id="{05E17D65-6B0F-D53E-2E84-E04355EE5C27}"/>
              </a:ext>
            </a:extLst>
          </p:cNvPr>
          <p:cNvSpPr txBox="1"/>
          <p:nvPr/>
        </p:nvSpPr>
        <p:spPr>
          <a:xfrm>
            <a:off x="1943701" y="2203972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38">
            <a:extLst>
              <a:ext uri="{FF2B5EF4-FFF2-40B4-BE49-F238E27FC236}">
                <a16:creationId xmlns:a16="http://schemas.microsoft.com/office/drawing/2014/main" xmlns="" id="{53C33C54-0B38-D769-2F42-1232E32B9EBE}"/>
              </a:ext>
            </a:extLst>
          </p:cNvPr>
          <p:cNvSpPr txBox="1"/>
          <p:nvPr/>
        </p:nvSpPr>
        <p:spPr>
          <a:xfrm>
            <a:off x="1943701" y="2077708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39">
            <a:extLst>
              <a:ext uri="{FF2B5EF4-FFF2-40B4-BE49-F238E27FC236}">
                <a16:creationId xmlns:a16="http://schemas.microsoft.com/office/drawing/2014/main" xmlns="" id="{F3CC4B9B-B0E0-E3B0-C977-29B8FF9EFA72}"/>
              </a:ext>
            </a:extLst>
          </p:cNvPr>
          <p:cNvSpPr txBox="1"/>
          <p:nvPr/>
        </p:nvSpPr>
        <p:spPr>
          <a:xfrm>
            <a:off x="2021940" y="3213827"/>
            <a:ext cx="3745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xmlns="" id="{60235D73-0463-E796-EAB2-DF185EBD2500}"/>
              </a:ext>
            </a:extLst>
          </p:cNvPr>
          <p:cNvCxnSpPr>
            <a:cxnSpLocks/>
          </p:cNvCxnSpPr>
          <p:nvPr/>
        </p:nvCxnSpPr>
        <p:spPr>
          <a:xfrm>
            <a:off x="2266219" y="2054752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xmlns="" id="{E8FABD0A-E896-2379-2522-79220664ABE7}"/>
              </a:ext>
            </a:extLst>
          </p:cNvPr>
          <p:cNvCxnSpPr>
            <a:cxnSpLocks/>
          </p:cNvCxnSpPr>
          <p:nvPr/>
        </p:nvCxnSpPr>
        <p:spPr>
          <a:xfrm>
            <a:off x="2266219" y="2195924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xmlns="" id="{E5945691-6664-5380-2FA3-01FF6EE6C019}"/>
              </a:ext>
            </a:extLst>
          </p:cNvPr>
          <p:cNvCxnSpPr>
            <a:cxnSpLocks/>
          </p:cNvCxnSpPr>
          <p:nvPr/>
        </p:nvCxnSpPr>
        <p:spPr>
          <a:xfrm>
            <a:off x="2266219" y="2342784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xmlns="" id="{F065DD19-C59E-E532-A4C7-0BB62E8DF4F8}"/>
              </a:ext>
            </a:extLst>
          </p:cNvPr>
          <p:cNvCxnSpPr>
            <a:cxnSpLocks/>
          </p:cNvCxnSpPr>
          <p:nvPr/>
        </p:nvCxnSpPr>
        <p:spPr>
          <a:xfrm>
            <a:off x="2266219" y="2655428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xmlns="" id="{E9524257-987B-C3FD-601F-590F9EDE0720}"/>
              </a:ext>
            </a:extLst>
          </p:cNvPr>
          <p:cNvCxnSpPr>
            <a:cxnSpLocks/>
          </p:cNvCxnSpPr>
          <p:nvPr/>
        </p:nvCxnSpPr>
        <p:spPr>
          <a:xfrm>
            <a:off x="2266219" y="2867286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xmlns="" id="{5A91BD06-FB11-6471-E5B4-E437E0BCACAC}"/>
              </a:ext>
            </a:extLst>
          </p:cNvPr>
          <p:cNvCxnSpPr>
            <a:cxnSpLocks/>
          </p:cNvCxnSpPr>
          <p:nvPr/>
        </p:nvCxnSpPr>
        <p:spPr>
          <a:xfrm>
            <a:off x="2266219" y="3359614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文本框 30">
            <a:extLst>
              <a:ext uri="{FF2B5EF4-FFF2-40B4-BE49-F238E27FC236}">
                <a16:creationId xmlns:a16="http://schemas.microsoft.com/office/drawing/2014/main" xmlns="" id="{4B783CFA-29AE-0367-33EE-C238D59254B2}"/>
              </a:ext>
            </a:extLst>
          </p:cNvPr>
          <p:cNvSpPr txBox="1"/>
          <p:nvPr/>
        </p:nvSpPr>
        <p:spPr>
          <a:xfrm>
            <a:off x="2014320" y="4622912"/>
            <a:ext cx="360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31">
            <a:extLst>
              <a:ext uri="{FF2B5EF4-FFF2-40B4-BE49-F238E27FC236}">
                <a16:creationId xmlns:a16="http://schemas.microsoft.com/office/drawing/2014/main" xmlns="" id="{340C609B-777E-1E99-30CC-0676A8DA2010}"/>
              </a:ext>
            </a:extLst>
          </p:cNvPr>
          <p:cNvSpPr txBox="1"/>
          <p:nvPr/>
        </p:nvSpPr>
        <p:spPr>
          <a:xfrm>
            <a:off x="2014320" y="4817501"/>
            <a:ext cx="3745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1">
            <a:extLst>
              <a:ext uri="{FF2B5EF4-FFF2-40B4-BE49-F238E27FC236}">
                <a16:creationId xmlns:a16="http://schemas.microsoft.com/office/drawing/2014/main" xmlns="" id="{3CCB4981-0531-C55D-F4C8-EF4871EF99F8}"/>
              </a:ext>
            </a:extLst>
          </p:cNvPr>
          <p:cNvSpPr txBox="1"/>
          <p:nvPr/>
        </p:nvSpPr>
        <p:spPr>
          <a:xfrm>
            <a:off x="1939079" y="4059270"/>
            <a:ext cx="4584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2">
            <a:extLst>
              <a:ext uri="{FF2B5EF4-FFF2-40B4-BE49-F238E27FC236}">
                <a16:creationId xmlns:a16="http://schemas.microsoft.com/office/drawing/2014/main" xmlns="" id="{593B7A10-55EA-1733-47F7-429127ACDFD6}"/>
              </a:ext>
            </a:extLst>
          </p:cNvPr>
          <p:cNvSpPr txBox="1"/>
          <p:nvPr/>
        </p:nvSpPr>
        <p:spPr>
          <a:xfrm>
            <a:off x="1939079" y="4369389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38">
            <a:extLst>
              <a:ext uri="{FF2B5EF4-FFF2-40B4-BE49-F238E27FC236}">
                <a16:creationId xmlns:a16="http://schemas.microsoft.com/office/drawing/2014/main" xmlns="" id="{FACAA4FC-097C-91F4-517C-8D0221B1F987}"/>
              </a:ext>
            </a:extLst>
          </p:cNvPr>
          <p:cNvSpPr txBox="1"/>
          <p:nvPr/>
        </p:nvSpPr>
        <p:spPr>
          <a:xfrm>
            <a:off x="1939079" y="4216333"/>
            <a:ext cx="4650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39">
            <a:extLst>
              <a:ext uri="{FF2B5EF4-FFF2-40B4-BE49-F238E27FC236}">
                <a16:creationId xmlns:a16="http://schemas.microsoft.com/office/drawing/2014/main" xmlns="" id="{58B760DD-33E0-02A7-F9BB-A5EDFE14D34C}"/>
              </a:ext>
            </a:extLst>
          </p:cNvPr>
          <p:cNvSpPr txBox="1"/>
          <p:nvPr/>
        </p:nvSpPr>
        <p:spPr>
          <a:xfrm>
            <a:off x="2014319" y="5336365"/>
            <a:ext cx="360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xmlns="" id="{EAC86F10-F96B-ABDB-4734-D3F1521667DF}"/>
              </a:ext>
            </a:extLst>
          </p:cNvPr>
          <p:cNvCxnSpPr>
            <a:cxnSpLocks/>
          </p:cNvCxnSpPr>
          <p:nvPr/>
        </p:nvCxnSpPr>
        <p:spPr>
          <a:xfrm>
            <a:off x="2266219" y="4214992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xmlns="" id="{F99E3F2E-3531-F866-9183-96BD27C48ADF}"/>
              </a:ext>
            </a:extLst>
          </p:cNvPr>
          <p:cNvCxnSpPr>
            <a:cxnSpLocks/>
          </p:cNvCxnSpPr>
          <p:nvPr/>
        </p:nvCxnSpPr>
        <p:spPr>
          <a:xfrm>
            <a:off x="2266219" y="4354039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xmlns="" id="{4F9005A9-25B4-7385-35E4-C3511F00F600}"/>
              </a:ext>
            </a:extLst>
          </p:cNvPr>
          <p:cNvCxnSpPr>
            <a:cxnSpLocks/>
          </p:cNvCxnSpPr>
          <p:nvPr/>
        </p:nvCxnSpPr>
        <p:spPr>
          <a:xfrm>
            <a:off x="2266219" y="4487236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xmlns="" id="{69467094-3F16-3308-4DD9-BD3B5BD362FD}"/>
              </a:ext>
            </a:extLst>
          </p:cNvPr>
          <p:cNvCxnSpPr>
            <a:cxnSpLocks/>
          </p:cNvCxnSpPr>
          <p:nvPr/>
        </p:nvCxnSpPr>
        <p:spPr>
          <a:xfrm>
            <a:off x="2266219" y="4771972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xmlns="" id="{3EAF39A2-B384-DD93-8DC3-B151FCFF7EA5}"/>
              </a:ext>
            </a:extLst>
          </p:cNvPr>
          <p:cNvCxnSpPr>
            <a:cxnSpLocks/>
          </p:cNvCxnSpPr>
          <p:nvPr/>
        </p:nvCxnSpPr>
        <p:spPr>
          <a:xfrm>
            <a:off x="2266219" y="4929211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xmlns="" id="{B5AA58F2-54A2-1DD8-5371-773B1CC91767}"/>
              </a:ext>
            </a:extLst>
          </p:cNvPr>
          <p:cNvCxnSpPr>
            <a:cxnSpLocks/>
          </p:cNvCxnSpPr>
          <p:nvPr/>
        </p:nvCxnSpPr>
        <p:spPr>
          <a:xfrm>
            <a:off x="2266219" y="5460560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20A9B392-566E-D22E-60D5-24CFD6F127BC}"/>
              </a:ext>
            </a:extLst>
          </p:cNvPr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81"/>
          <a:stretch/>
        </p:blipFill>
        <p:spPr>
          <a:xfrm>
            <a:off x="2471989" y="3109065"/>
            <a:ext cx="1803600" cy="45360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9877A82A-744C-5E32-0D54-94EE9CC7F8F2}"/>
              </a:ext>
            </a:extLst>
          </p:cNvPr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32" t="9894"/>
          <a:stretch/>
        </p:blipFill>
        <p:spPr>
          <a:xfrm>
            <a:off x="2446331" y="4649872"/>
            <a:ext cx="1803600" cy="4536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97D2AFD2-072F-F038-8021-2DA050A2F23A}"/>
              </a:ext>
            </a:extLst>
          </p:cNvPr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85" r="6424" b="12029"/>
          <a:stretch/>
        </p:blipFill>
        <p:spPr>
          <a:xfrm>
            <a:off x="4457384" y="3109065"/>
            <a:ext cx="1803600" cy="4536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E3AC08D4-F3ED-358E-9BE9-EC6E023D11B5}"/>
              </a:ext>
            </a:extLst>
          </p:cNvPr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32" t="7653" r="9598" b="-12972"/>
          <a:stretch/>
        </p:blipFill>
        <p:spPr>
          <a:xfrm>
            <a:off x="4442091" y="4649872"/>
            <a:ext cx="1803600" cy="453600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xmlns="" id="{5732D267-4F58-5935-D3D6-862C03C65E58}"/>
              </a:ext>
            </a:extLst>
          </p:cNvPr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48" r="3434" b="2618"/>
          <a:stretch/>
        </p:blipFill>
        <p:spPr>
          <a:xfrm>
            <a:off x="4457384" y="2540462"/>
            <a:ext cx="1803600" cy="453600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xmlns="" id="{B0C22CFA-F6B0-CA65-2426-C492992C5255}"/>
              </a:ext>
            </a:extLst>
          </p:cNvPr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37" t="1" r="7072" b="571"/>
          <a:stretch/>
        </p:blipFill>
        <p:spPr>
          <a:xfrm>
            <a:off x="4449456" y="4109240"/>
            <a:ext cx="1803600" cy="453600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xmlns="" id="{C9F27E1C-576B-DB7E-FC8D-A2BBBC4B412C}"/>
              </a:ext>
            </a:extLst>
          </p:cNvPr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90" b="2007"/>
          <a:stretch/>
        </p:blipFill>
        <p:spPr>
          <a:xfrm>
            <a:off x="4449456" y="1967288"/>
            <a:ext cx="1803600" cy="453600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xmlns="" id="{9606A0A7-35B9-0A1F-A83D-7FF66BD16904}"/>
              </a:ext>
            </a:extLst>
          </p:cNvPr>
          <p:cNvPicPr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4" b="7953"/>
          <a:stretch/>
        </p:blipFill>
        <p:spPr>
          <a:xfrm>
            <a:off x="2471989" y="2540462"/>
            <a:ext cx="1803600" cy="453600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xmlns="" id="{EDCD5004-0612-1908-6EBB-22224A127D69}"/>
              </a:ext>
            </a:extLst>
          </p:cNvPr>
          <p:cNvPicPr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25" b="-2438"/>
          <a:stretch/>
        </p:blipFill>
        <p:spPr>
          <a:xfrm>
            <a:off x="2480368" y="1967288"/>
            <a:ext cx="1803600" cy="453600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xmlns="" id="{17FCA518-90F1-DAF8-E78E-04E88692D9E4}"/>
              </a:ext>
            </a:extLst>
          </p:cNvPr>
          <p:cNvPicPr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66" t="1654" r="9113" b="-1487"/>
          <a:stretch/>
        </p:blipFill>
        <p:spPr>
          <a:xfrm>
            <a:off x="2453042" y="4109240"/>
            <a:ext cx="1803600" cy="453600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xmlns="" id="{31457396-4CCA-3062-0872-1D03DBB79B25}"/>
              </a:ext>
            </a:extLst>
          </p:cNvPr>
          <p:cNvPicPr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98" r="14282"/>
          <a:stretch/>
        </p:blipFill>
        <p:spPr>
          <a:xfrm>
            <a:off x="6428898" y="3109065"/>
            <a:ext cx="1803600" cy="453600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xmlns="" id="{A27E75E0-1A4D-C6D8-FCD8-F27E3005B85C}"/>
              </a:ext>
            </a:extLst>
          </p:cNvPr>
          <p:cNvPicPr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86" t="18178" r="8180" b="11676"/>
          <a:stretch/>
        </p:blipFill>
        <p:spPr>
          <a:xfrm>
            <a:off x="6414360" y="4649872"/>
            <a:ext cx="1803600" cy="453600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xmlns="" id="{87BE9B6B-0BB9-A9C9-67FD-A75F2766277B}"/>
              </a:ext>
            </a:extLst>
          </p:cNvPr>
          <p:cNvPicPr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77" t="1" r="3372" b="-7171"/>
          <a:stretch/>
        </p:blipFill>
        <p:spPr>
          <a:xfrm>
            <a:off x="6428898" y="2540462"/>
            <a:ext cx="1803600" cy="453600"/>
          </a:xfrm>
          <a:prstGeom prst="rect">
            <a:avLst/>
          </a:prstGeom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xmlns="" id="{02AB44E0-35FA-5744-84A6-8D152B8FA6AA}"/>
              </a:ext>
            </a:extLst>
          </p:cNvPr>
          <p:cNvPicPr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18" t="30189" r="1629" b="-194"/>
          <a:stretch/>
        </p:blipFill>
        <p:spPr>
          <a:xfrm>
            <a:off x="6419521" y="4109240"/>
            <a:ext cx="1803600" cy="453600"/>
          </a:xfrm>
          <a:prstGeom prst="rect">
            <a:avLst/>
          </a:prstGeom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xmlns="" id="{42626C2D-E259-AC99-C434-885896F11F98}"/>
              </a:ext>
            </a:extLst>
          </p:cNvPr>
          <p:cNvPicPr>
            <a:picLocks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25" b="-5130"/>
          <a:stretch/>
        </p:blipFill>
        <p:spPr>
          <a:xfrm>
            <a:off x="6428898" y="1967288"/>
            <a:ext cx="1803600" cy="453600"/>
          </a:xfrm>
          <a:prstGeom prst="rect">
            <a:avLst/>
          </a:prstGeom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xmlns="" id="{BEB65CBB-5806-4E8A-B434-6A663D4FC7F8}"/>
              </a:ext>
            </a:extLst>
          </p:cNvPr>
          <p:cNvPicPr>
            <a:picLocks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9456" y="5187485"/>
            <a:ext cx="1803600" cy="453600"/>
          </a:xfrm>
          <a:prstGeom prst="rect">
            <a:avLst/>
          </a:prstGeom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xmlns="" id="{3C56238E-7C95-A8D9-1512-E8FDEBF65F85}"/>
              </a:ext>
            </a:extLst>
          </p:cNvPr>
          <p:cNvPicPr>
            <a:picLocks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65" r="11666" b="-13094"/>
          <a:stretch/>
        </p:blipFill>
        <p:spPr>
          <a:xfrm>
            <a:off x="2446331" y="5189268"/>
            <a:ext cx="1803600" cy="453600"/>
          </a:xfrm>
          <a:prstGeom prst="rect">
            <a:avLst/>
          </a:prstGeom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xmlns="" id="{B69E5FF8-9184-74FA-03E6-12FB3F129EC0}"/>
              </a:ext>
            </a:extLst>
          </p:cNvPr>
          <p:cNvPicPr>
            <a:picLocks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50" t="1" b="-4828"/>
          <a:stretch/>
        </p:blipFill>
        <p:spPr>
          <a:xfrm>
            <a:off x="6419008" y="5163533"/>
            <a:ext cx="1803600" cy="45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16343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D69B5FBE-F192-141F-0D51-7D75A4070EAA}"/>
              </a:ext>
            </a:extLst>
          </p:cNvPr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581" r="3972" b="50987"/>
          <a:stretch/>
        </p:blipFill>
        <p:spPr>
          <a:xfrm>
            <a:off x="1971214" y="1920365"/>
            <a:ext cx="1803600" cy="4536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AA61D33E-85BA-ADCE-C41C-4A275C60DC4E}"/>
              </a:ext>
            </a:extLst>
          </p:cNvPr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519" r="4416" b="39210"/>
          <a:stretch/>
        </p:blipFill>
        <p:spPr>
          <a:xfrm>
            <a:off x="1972354" y="2442600"/>
            <a:ext cx="1803600" cy="4536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0049D33A-79E3-3F57-0037-2B499CDD77F4}"/>
              </a:ext>
            </a:extLst>
          </p:cNvPr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43" t="21804" r="8166" b="63662"/>
          <a:stretch/>
        </p:blipFill>
        <p:spPr>
          <a:xfrm>
            <a:off x="4371169" y="3501008"/>
            <a:ext cx="1803600" cy="4536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xmlns="" id="{006BD688-9C5E-24FC-B24C-3988064ACE3F}"/>
              </a:ext>
            </a:extLst>
          </p:cNvPr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76" t="51912" r="-522" b="35323"/>
          <a:stretch/>
        </p:blipFill>
        <p:spPr>
          <a:xfrm>
            <a:off x="6851698" y="1955201"/>
            <a:ext cx="1803600" cy="4536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xmlns="" id="{AA0668A2-5C23-21B1-F17F-F4DC70EE9E09}"/>
              </a:ext>
            </a:extLst>
          </p:cNvPr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84" t="25150" r="7481" b="61788"/>
          <a:stretch/>
        </p:blipFill>
        <p:spPr>
          <a:xfrm>
            <a:off x="6870556" y="2513820"/>
            <a:ext cx="1803600" cy="45360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xmlns="" id="{F89D4CCE-62FF-BE41-5E8A-D0B8ACD8CCD9}"/>
              </a:ext>
            </a:extLst>
          </p:cNvPr>
          <p:cNvSpPr txBox="1"/>
          <p:nvPr/>
        </p:nvSpPr>
        <p:spPr>
          <a:xfrm>
            <a:off x="1411498" y="1834973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xmlns="" id="{54AD5EA5-52FE-1C4E-3358-943CA117C727}"/>
              </a:ext>
            </a:extLst>
          </p:cNvPr>
          <p:cNvSpPr txBox="1"/>
          <p:nvPr/>
        </p:nvSpPr>
        <p:spPr>
          <a:xfrm>
            <a:off x="1414458" y="2051111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xmlns="" id="{8A21E48F-683C-8C84-941D-EFA55A94F71F}"/>
              </a:ext>
            </a:extLst>
          </p:cNvPr>
          <p:cNvSpPr txBox="1"/>
          <p:nvPr/>
        </p:nvSpPr>
        <p:spPr>
          <a:xfrm>
            <a:off x="1412942" y="3501008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xmlns="" id="{08C470C8-9BED-B4C2-C516-79508985BCEC}"/>
              </a:ext>
            </a:extLst>
          </p:cNvPr>
          <p:cNvSpPr txBox="1"/>
          <p:nvPr/>
        </p:nvSpPr>
        <p:spPr>
          <a:xfrm>
            <a:off x="1403648" y="3680566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xmlns="" id="{CD10ACC3-0096-1D2F-2C80-35047D0D99E4}"/>
              </a:ext>
            </a:extLst>
          </p:cNvPr>
          <p:cNvSpPr txBox="1"/>
          <p:nvPr/>
        </p:nvSpPr>
        <p:spPr>
          <a:xfrm>
            <a:off x="1459868" y="2634861"/>
            <a:ext cx="420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xmlns="" id="{458174D8-F3CC-0FB2-0ED1-963F7880FCA2}"/>
              </a:ext>
            </a:extLst>
          </p:cNvPr>
          <p:cNvSpPr txBox="1"/>
          <p:nvPr/>
        </p:nvSpPr>
        <p:spPr>
          <a:xfrm>
            <a:off x="1449468" y="2496362"/>
            <a:ext cx="420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xmlns="" id="{3C741EB3-74B0-B6AC-8FA7-ADAF27A759D1}"/>
              </a:ext>
            </a:extLst>
          </p:cNvPr>
          <p:cNvSpPr txBox="1"/>
          <p:nvPr/>
        </p:nvSpPr>
        <p:spPr>
          <a:xfrm>
            <a:off x="7336383" y="1394091"/>
            <a:ext cx="871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repeat3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xmlns="" id="{9D133486-0222-CA8C-F36F-F8351690EA25}"/>
              </a:ext>
            </a:extLst>
          </p:cNvPr>
          <p:cNvSpPr txBox="1"/>
          <p:nvPr/>
        </p:nvSpPr>
        <p:spPr>
          <a:xfrm>
            <a:off x="2475918" y="1390578"/>
            <a:ext cx="871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repeat1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xmlns="" id="{D9FC6203-771B-8932-3163-58D32214E802}"/>
              </a:ext>
            </a:extLst>
          </p:cNvPr>
          <p:cNvSpPr txBox="1"/>
          <p:nvPr/>
        </p:nvSpPr>
        <p:spPr>
          <a:xfrm>
            <a:off x="4854882" y="1390578"/>
            <a:ext cx="871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repeat2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FF14EDA2-2905-CEB3-08BE-BEAABAEA546E}"/>
              </a:ext>
            </a:extLst>
          </p:cNvPr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21" b="10359"/>
          <a:stretch/>
        </p:blipFill>
        <p:spPr>
          <a:xfrm>
            <a:off x="6853359" y="4073520"/>
            <a:ext cx="1803600" cy="4536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24901323-3BC6-CF23-BA67-D2870F9FB6AA}"/>
              </a:ext>
            </a:extLst>
          </p:cNvPr>
          <p:cNvPicPr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78" t="36404" r="1888" b="50534"/>
          <a:stretch/>
        </p:blipFill>
        <p:spPr>
          <a:xfrm>
            <a:off x="6863603" y="3523089"/>
            <a:ext cx="1803600" cy="453600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xmlns="" id="{5E81D001-7DC8-4106-37B9-85A36D304E84}"/>
              </a:ext>
            </a:extLst>
          </p:cNvPr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7452" y="4069773"/>
            <a:ext cx="1803600" cy="453600"/>
          </a:xfrm>
          <a:prstGeom prst="rect">
            <a:avLst/>
          </a:prstGeom>
        </p:spPr>
      </p:pic>
      <p:sp>
        <p:nvSpPr>
          <p:cNvPr id="50" name="文本框 49">
            <a:extLst>
              <a:ext uri="{FF2B5EF4-FFF2-40B4-BE49-F238E27FC236}">
                <a16:creationId xmlns:a16="http://schemas.microsoft.com/office/drawing/2014/main" xmlns="" id="{A3027143-EF3C-0B7E-43DE-C9DDFADA148D}"/>
              </a:ext>
            </a:extLst>
          </p:cNvPr>
          <p:cNvSpPr txBox="1"/>
          <p:nvPr/>
        </p:nvSpPr>
        <p:spPr>
          <a:xfrm>
            <a:off x="1464143" y="4256920"/>
            <a:ext cx="420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xmlns="" id="{3DB701F2-6802-65E7-4678-521101151BD3}"/>
              </a:ext>
            </a:extLst>
          </p:cNvPr>
          <p:cNvSpPr txBox="1"/>
          <p:nvPr/>
        </p:nvSpPr>
        <p:spPr>
          <a:xfrm>
            <a:off x="1466632" y="4077362"/>
            <a:ext cx="420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xmlns="" id="{EC911D98-6FCD-FD7D-1B7C-06AF91F56912}"/>
              </a:ext>
            </a:extLst>
          </p:cNvPr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1561" y="3510558"/>
            <a:ext cx="1803600" cy="453600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xmlns="" id="{FBDACE6F-5E60-5D2C-E4DE-21DC935FD680}"/>
              </a:ext>
            </a:extLst>
          </p:cNvPr>
          <p:cNvPicPr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39" t="5109"/>
          <a:stretch/>
        </p:blipFill>
        <p:spPr>
          <a:xfrm>
            <a:off x="4356686" y="4069773"/>
            <a:ext cx="1803600" cy="453600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xmlns="" id="{2DB89628-632D-63DC-112D-50A072FA9909}"/>
              </a:ext>
            </a:extLst>
          </p:cNvPr>
          <p:cNvPicPr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0"/>
          <a:stretch/>
        </p:blipFill>
        <p:spPr>
          <a:xfrm>
            <a:off x="4362046" y="2513820"/>
            <a:ext cx="1803600" cy="453600"/>
          </a:xfrm>
          <a:prstGeom prst="rect">
            <a:avLst/>
          </a:prstGeom>
        </p:spPr>
      </p:pic>
      <p:sp>
        <p:nvSpPr>
          <p:cNvPr id="45" name="文本框 44">
            <a:extLst>
              <a:ext uri="{FF2B5EF4-FFF2-40B4-BE49-F238E27FC236}">
                <a16:creationId xmlns:a16="http://schemas.microsoft.com/office/drawing/2014/main" xmlns="" id="{19517AF1-4794-3FBE-5D57-4B51015963E8}"/>
              </a:ext>
            </a:extLst>
          </p:cNvPr>
          <p:cNvSpPr txBox="1"/>
          <p:nvPr/>
        </p:nvSpPr>
        <p:spPr>
          <a:xfrm>
            <a:off x="1690240" y="692696"/>
            <a:ext cx="6626176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presentative original images of western blots for Figure </a:t>
            </a:r>
            <a:r>
              <a:rPr lang="en-US" altLang="zh-CN" sz="1800" b="1" kern="100" dirty="0" smtClean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7A</a:t>
            </a:r>
            <a:endParaRPr lang="zh-CN" altLang="zh-CN" sz="14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xmlns="" id="{459BAE8E-91DC-83F5-E15A-54C5910C5B37}"/>
              </a:ext>
            </a:extLst>
          </p:cNvPr>
          <p:cNvCxnSpPr>
            <a:cxnSpLocks/>
          </p:cNvCxnSpPr>
          <p:nvPr/>
        </p:nvCxnSpPr>
        <p:spPr>
          <a:xfrm>
            <a:off x="1757409" y="1994364"/>
            <a:ext cx="17572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文本框 59">
            <a:extLst>
              <a:ext uri="{FF2B5EF4-FFF2-40B4-BE49-F238E27FC236}">
                <a16:creationId xmlns:a16="http://schemas.microsoft.com/office/drawing/2014/main" xmlns="" id="{BF5491A8-3676-FFA9-9D35-EF261CDC00C1}"/>
              </a:ext>
            </a:extLst>
          </p:cNvPr>
          <p:cNvSpPr txBox="1"/>
          <p:nvPr/>
        </p:nvSpPr>
        <p:spPr>
          <a:xfrm>
            <a:off x="649943" y="1960821"/>
            <a:ext cx="753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p-eNOS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xmlns="" id="{989BEFCD-2F82-20BD-5B0F-AE1A30DCD770}"/>
              </a:ext>
            </a:extLst>
          </p:cNvPr>
          <p:cNvSpPr txBox="1"/>
          <p:nvPr/>
        </p:nvSpPr>
        <p:spPr>
          <a:xfrm>
            <a:off x="635088" y="2577661"/>
            <a:ext cx="7685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xmlns="" id="{0C8EBE71-1211-CC62-D108-EF640E8B7E49}"/>
              </a:ext>
            </a:extLst>
          </p:cNvPr>
          <p:cNvSpPr txBox="1"/>
          <p:nvPr/>
        </p:nvSpPr>
        <p:spPr>
          <a:xfrm>
            <a:off x="586444" y="3502877"/>
            <a:ext cx="8172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eNOS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xmlns="" id="{76C27D94-0569-10A2-68CD-130E6BC38BE4}"/>
              </a:ext>
            </a:extLst>
          </p:cNvPr>
          <p:cNvSpPr txBox="1"/>
          <p:nvPr/>
        </p:nvSpPr>
        <p:spPr>
          <a:xfrm>
            <a:off x="607018" y="4168947"/>
            <a:ext cx="794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xmlns="" id="{AD0FA442-C60E-AC48-24D4-8D9D824F21ED}"/>
              </a:ext>
            </a:extLst>
          </p:cNvPr>
          <p:cNvCxnSpPr>
            <a:cxnSpLocks/>
          </p:cNvCxnSpPr>
          <p:nvPr/>
        </p:nvCxnSpPr>
        <p:spPr>
          <a:xfrm>
            <a:off x="1762242" y="2202874"/>
            <a:ext cx="17572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xmlns="" id="{B4EE0A6C-0351-62AE-9BB2-43EB6DA0A149}"/>
              </a:ext>
            </a:extLst>
          </p:cNvPr>
          <p:cNvCxnSpPr>
            <a:cxnSpLocks/>
          </p:cNvCxnSpPr>
          <p:nvPr/>
        </p:nvCxnSpPr>
        <p:spPr>
          <a:xfrm>
            <a:off x="1755685" y="2623800"/>
            <a:ext cx="17572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xmlns="" id="{C0E8964D-51AF-3596-60C0-21D1B5D94800}"/>
              </a:ext>
            </a:extLst>
          </p:cNvPr>
          <p:cNvCxnSpPr>
            <a:cxnSpLocks/>
          </p:cNvCxnSpPr>
          <p:nvPr/>
        </p:nvCxnSpPr>
        <p:spPr>
          <a:xfrm>
            <a:off x="1770767" y="2738440"/>
            <a:ext cx="17572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xmlns="" id="{3BCC5C71-5D1A-B146-C845-6044A17FC3CA}"/>
              </a:ext>
            </a:extLst>
          </p:cNvPr>
          <p:cNvCxnSpPr>
            <a:cxnSpLocks/>
          </p:cNvCxnSpPr>
          <p:nvPr/>
        </p:nvCxnSpPr>
        <p:spPr>
          <a:xfrm>
            <a:off x="1770767" y="3647128"/>
            <a:ext cx="17572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xmlns="" id="{ED6659C8-01F1-FF46-A7F0-1EFD4322840E}"/>
              </a:ext>
            </a:extLst>
          </p:cNvPr>
          <p:cNvCxnSpPr>
            <a:cxnSpLocks/>
          </p:cNvCxnSpPr>
          <p:nvPr/>
        </p:nvCxnSpPr>
        <p:spPr>
          <a:xfrm>
            <a:off x="1791422" y="3819065"/>
            <a:ext cx="17572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xmlns="" id="{459BAE8E-91DC-83F5-E15A-54C5910C5B37}"/>
              </a:ext>
            </a:extLst>
          </p:cNvPr>
          <p:cNvCxnSpPr>
            <a:cxnSpLocks/>
          </p:cNvCxnSpPr>
          <p:nvPr/>
        </p:nvCxnSpPr>
        <p:spPr>
          <a:xfrm>
            <a:off x="1778628" y="4395420"/>
            <a:ext cx="17572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xmlns="" id="{459BAE8E-91DC-83F5-E15A-54C5910C5B37}"/>
              </a:ext>
            </a:extLst>
          </p:cNvPr>
          <p:cNvCxnSpPr>
            <a:cxnSpLocks/>
          </p:cNvCxnSpPr>
          <p:nvPr/>
        </p:nvCxnSpPr>
        <p:spPr>
          <a:xfrm>
            <a:off x="1778528" y="4215161"/>
            <a:ext cx="17572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1">
            <a:extLst>
              <a:ext uri="{FF2B5EF4-FFF2-40B4-BE49-F238E27FC236}">
                <a16:creationId xmlns:a16="http://schemas.microsoft.com/office/drawing/2014/main" xmlns="" id="{F800AD7E-0EC4-1426-254F-2ED074C3D8F1}"/>
              </a:ext>
            </a:extLst>
          </p:cNvPr>
          <p:cNvSpPr txBox="1"/>
          <p:nvPr/>
        </p:nvSpPr>
        <p:spPr>
          <a:xfrm>
            <a:off x="6337929" y="1898182"/>
            <a:ext cx="526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2">
            <a:extLst>
              <a:ext uri="{FF2B5EF4-FFF2-40B4-BE49-F238E27FC236}">
                <a16:creationId xmlns:a16="http://schemas.microsoft.com/office/drawing/2014/main" xmlns="" id="{7DFB66B1-1628-B895-881F-B1CB4ABA978B}"/>
              </a:ext>
            </a:extLst>
          </p:cNvPr>
          <p:cNvSpPr txBox="1"/>
          <p:nvPr/>
        </p:nvSpPr>
        <p:spPr>
          <a:xfrm>
            <a:off x="6334177" y="2232893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6" name="直接连接符 75">
            <a:extLst>
              <a:ext uri="{FF2B5EF4-FFF2-40B4-BE49-F238E27FC236}">
                <a16:creationId xmlns:a16="http://schemas.microsoft.com/office/drawing/2014/main" xmlns="" id="{47A09779-AB82-C1C9-9F41-2C75A707B6A1}"/>
              </a:ext>
            </a:extLst>
          </p:cNvPr>
          <p:cNvCxnSpPr>
            <a:cxnSpLocks/>
          </p:cNvCxnSpPr>
          <p:nvPr/>
        </p:nvCxnSpPr>
        <p:spPr>
          <a:xfrm>
            <a:off x="6667541" y="2031037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直接连接符 76">
            <a:extLst>
              <a:ext uri="{FF2B5EF4-FFF2-40B4-BE49-F238E27FC236}">
                <a16:creationId xmlns:a16="http://schemas.microsoft.com/office/drawing/2014/main" xmlns="" id="{5CD50AC8-AF4D-AC4C-D014-4744EFDE56AB}"/>
              </a:ext>
            </a:extLst>
          </p:cNvPr>
          <p:cNvCxnSpPr>
            <a:cxnSpLocks/>
          </p:cNvCxnSpPr>
          <p:nvPr/>
        </p:nvCxnSpPr>
        <p:spPr>
          <a:xfrm>
            <a:off x="6667541" y="2225897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xmlns="" id="{7F2F5951-04C0-5DF5-D44D-7F952B9B44C3}"/>
              </a:ext>
            </a:extLst>
          </p:cNvPr>
          <p:cNvCxnSpPr>
            <a:cxnSpLocks/>
          </p:cNvCxnSpPr>
          <p:nvPr/>
        </p:nvCxnSpPr>
        <p:spPr>
          <a:xfrm>
            <a:off x="6667541" y="2373965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文本框 78">
            <a:extLst>
              <a:ext uri="{FF2B5EF4-FFF2-40B4-BE49-F238E27FC236}">
                <a16:creationId xmlns:a16="http://schemas.microsoft.com/office/drawing/2014/main" xmlns="" id="{8022FF7C-4D05-628A-2FD7-9FF897A532A3}"/>
              </a:ext>
            </a:extLst>
          </p:cNvPr>
          <p:cNvSpPr txBox="1"/>
          <p:nvPr/>
        </p:nvSpPr>
        <p:spPr>
          <a:xfrm>
            <a:off x="3789614" y="1888670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xmlns="" id="{A007C7F3-7142-6424-A83C-E58FA3BC9A2C}"/>
              </a:ext>
            </a:extLst>
          </p:cNvPr>
          <p:cNvSpPr txBox="1"/>
          <p:nvPr/>
        </p:nvSpPr>
        <p:spPr>
          <a:xfrm>
            <a:off x="3789614" y="2136546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xmlns="" id="{5EF660FC-4763-283A-9A51-B6D29DEF2167}"/>
              </a:ext>
            </a:extLst>
          </p:cNvPr>
          <p:cNvSpPr txBox="1"/>
          <p:nvPr/>
        </p:nvSpPr>
        <p:spPr>
          <a:xfrm>
            <a:off x="3814593" y="3515015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xmlns="" id="{8A94B951-2066-2A0D-5B7E-CBE9887FDB0B}"/>
              </a:ext>
            </a:extLst>
          </p:cNvPr>
          <p:cNvSpPr txBox="1"/>
          <p:nvPr/>
        </p:nvSpPr>
        <p:spPr>
          <a:xfrm>
            <a:off x="3814593" y="3647128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xmlns="" id="{B40E1C80-4925-B274-A295-9F377BD2C8E1}"/>
              </a:ext>
            </a:extLst>
          </p:cNvPr>
          <p:cNvSpPr txBox="1"/>
          <p:nvPr/>
        </p:nvSpPr>
        <p:spPr>
          <a:xfrm>
            <a:off x="3829927" y="2731291"/>
            <a:ext cx="420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xmlns="" id="{BB25F38B-86A1-A3F9-CC7A-D3FE02694062}"/>
              </a:ext>
            </a:extLst>
          </p:cNvPr>
          <p:cNvSpPr txBox="1"/>
          <p:nvPr/>
        </p:nvSpPr>
        <p:spPr>
          <a:xfrm>
            <a:off x="3829927" y="2592792"/>
            <a:ext cx="420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xmlns="" id="{BB0995D3-E16B-08F0-E2F2-A9B5C2C64B14}"/>
              </a:ext>
            </a:extLst>
          </p:cNvPr>
          <p:cNvSpPr txBox="1"/>
          <p:nvPr/>
        </p:nvSpPr>
        <p:spPr>
          <a:xfrm>
            <a:off x="3852600" y="4280312"/>
            <a:ext cx="420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xmlns="" id="{6735D5F3-AC93-CD4E-EED0-6951A99F0901}"/>
              </a:ext>
            </a:extLst>
          </p:cNvPr>
          <p:cNvSpPr txBox="1"/>
          <p:nvPr/>
        </p:nvSpPr>
        <p:spPr>
          <a:xfrm>
            <a:off x="3854854" y="4083716"/>
            <a:ext cx="420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xmlns="" id="{93F222A4-3F16-4BC4-C1E8-EB364ADFD57E}"/>
              </a:ext>
            </a:extLst>
          </p:cNvPr>
          <p:cNvCxnSpPr>
            <a:cxnSpLocks/>
          </p:cNvCxnSpPr>
          <p:nvPr/>
        </p:nvCxnSpPr>
        <p:spPr>
          <a:xfrm>
            <a:off x="4164968" y="2031037"/>
            <a:ext cx="17572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xmlns="" id="{063DABF5-4AE2-45D6-C716-80280DFAF69C}"/>
              </a:ext>
            </a:extLst>
          </p:cNvPr>
          <p:cNvCxnSpPr>
            <a:cxnSpLocks/>
          </p:cNvCxnSpPr>
          <p:nvPr/>
        </p:nvCxnSpPr>
        <p:spPr>
          <a:xfrm>
            <a:off x="4164968" y="2264421"/>
            <a:ext cx="17572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xmlns="" id="{A353D9BF-BDCF-E8AF-451A-16945DD759EA}"/>
              </a:ext>
            </a:extLst>
          </p:cNvPr>
          <p:cNvCxnSpPr>
            <a:cxnSpLocks/>
          </p:cNvCxnSpPr>
          <p:nvPr/>
        </p:nvCxnSpPr>
        <p:spPr>
          <a:xfrm>
            <a:off x="4164968" y="2747514"/>
            <a:ext cx="17572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xmlns="" id="{33CCBC61-AD77-EB80-142B-1EE8B4BB970C}"/>
              </a:ext>
            </a:extLst>
          </p:cNvPr>
          <p:cNvCxnSpPr>
            <a:cxnSpLocks/>
          </p:cNvCxnSpPr>
          <p:nvPr/>
        </p:nvCxnSpPr>
        <p:spPr>
          <a:xfrm>
            <a:off x="4164968" y="2877183"/>
            <a:ext cx="17572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xmlns="" id="{F612EA04-1534-6500-BB84-5E18FE986E70}"/>
              </a:ext>
            </a:extLst>
          </p:cNvPr>
          <p:cNvCxnSpPr>
            <a:cxnSpLocks/>
          </p:cNvCxnSpPr>
          <p:nvPr/>
        </p:nvCxnSpPr>
        <p:spPr>
          <a:xfrm>
            <a:off x="4164968" y="3639507"/>
            <a:ext cx="17572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xmlns="" id="{00C50EA1-6A3C-62CC-BACD-1B277D970906}"/>
              </a:ext>
            </a:extLst>
          </p:cNvPr>
          <p:cNvCxnSpPr>
            <a:cxnSpLocks/>
          </p:cNvCxnSpPr>
          <p:nvPr/>
        </p:nvCxnSpPr>
        <p:spPr>
          <a:xfrm>
            <a:off x="4164968" y="3778007"/>
            <a:ext cx="17572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xmlns="" id="{EF3ED97D-818A-BB2A-62AC-4A58E9628B67}"/>
              </a:ext>
            </a:extLst>
          </p:cNvPr>
          <p:cNvCxnSpPr>
            <a:cxnSpLocks/>
          </p:cNvCxnSpPr>
          <p:nvPr/>
        </p:nvCxnSpPr>
        <p:spPr>
          <a:xfrm>
            <a:off x="4164968" y="4395419"/>
            <a:ext cx="17572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4" name="直接连接符 93">
            <a:extLst>
              <a:ext uri="{FF2B5EF4-FFF2-40B4-BE49-F238E27FC236}">
                <a16:creationId xmlns:a16="http://schemas.microsoft.com/office/drawing/2014/main" xmlns="" id="{BD87ECB6-49D7-E88A-7ADA-B5E968CF31B6}"/>
              </a:ext>
            </a:extLst>
          </p:cNvPr>
          <p:cNvCxnSpPr>
            <a:cxnSpLocks/>
          </p:cNvCxnSpPr>
          <p:nvPr/>
        </p:nvCxnSpPr>
        <p:spPr>
          <a:xfrm>
            <a:off x="4164968" y="4215161"/>
            <a:ext cx="17572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文本框 94">
            <a:extLst>
              <a:ext uri="{FF2B5EF4-FFF2-40B4-BE49-F238E27FC236}">
                <a16:creationId xmlns:a16="http://schemas.microsoft.com/office/drawing/2014/main" xmlns="" id="{1CEE93C2-4BCC-4AE5-7FC1-0EAF100BE7B6}"/>
              </a:ext>
            </a:extLst>
          </p:cNvPr>
          <p:cNvSpPr txBox="1"/>
          <p:nvPr/>
        </p:nvSpPr>
        <p:spPr>
          <a:xfrm>
            <a:off x="6417375" y="2628854"/>
            <a:ext cx="3525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6" name="直接连接符 95">
            <a:extLst>
              <a:ext uri="{FF2B5EF4-FFF2-40B4-BE49-F238E27FC236}">
                <a16:creationId xmlns:a16="http://schemas.microsoft.com/office/drawing/2014/main" xmlns="" id="{2363ED84-2224-4794-982C-256EBBE673B2}"/>
              </a:ext>
            </a:extLst>
          </p:cNvPr>
          <p:cNvCxnSpPr>
            <a:cxnSpLocks/>
          </p:cNvCxnSpPr>
          <p:nvPr/>
        </p:nvCxnSpPr>
        <p:spPr>
          <a:xfrm>
            <a:off x="6667541" y="2782593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文本框 96">
            <a:extLst>
              <a:ext uri="{FF2B5EF4-FFF2-40B4-BE49-F238E27FC236}">
                <a16:creationId xmlns:a16="http://schemas.microsoft.com/office/drawing/2014/main" xmlns="" id="{B2A7BC53-D3DB-D9D2-9068-0819D04E2C49}"/>
              </a:ext>
            </a:extLst>
          </p:cNvPr>
          <p:cNvSpPr txBox="1"/>
          <p:nvPr/>
        </p:nvSpPr>
        <p:spPr>
          <a:xfrm>
            <a:off x="6410966" y="4135294"/>
            <a:ext cx="3932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8" name="直接连接符 97">
            <a:extLst>
              <a:ext uri="{FF2B5EF4-FFF2-40B4-BE49-F238E27FC236}">
                <a16:creationId xmlns:a16="http://schemas.microsoft.com/office/drawing/2014/main" xmlns="" id="{9C813DA1-0E45-870A-EA5A-5BB2EC1D4932}"/>
              </a:ext>
            </a:extLst>
          </p:cNvPr>
          <p:cNvCxnSpPr>
            <a:cxnSpLocks/>
          </p:cNvCxnSpPr>
          <p:nvPr/>
        </p:nvCxnSpPr>
        <p:spPr>
          <a:xfrm>
            <a:off x="6667541" y="4281745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文本框 1">
            <a:extLst>
              <a:ext uri="{FF2B5EF4-FFF2-40B4-BE49-F238E27FC236}">
                <a16:creationId xmlns:a16="http://schemas.microsoft.com/office/drawing/2014/main" xmlns="" id="{18689023-30E8-046D-BE2B-B06740521C25}"/>
              </a:ext>
            </a:extLst>
          </p:cNvPr>
          <p:cNvSpPr txBox="1"/>
          <p:nvPr/>
        </p:nvSpPr>
        <p:spPr>
          <a:xfrm>
            <a:off x="6339092" y="3548981"/>
            <a:ext cx="5290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文本框 2">
            <a:extLst>
              <a:ext uri="{FF2B5EF4-FFF2-40B4-BE49-F238E27FC236}">
                <a16:creationId xmlns:a16="http://schemas.microsoft.com/office/drawing/2014/main" xmlns="" id="{23D66A8E-9234-4434-D2E1-17136E8F6626}"/>
              </a:ext>
            </a:extLst>
          </p:cNvPr>
          <p:cNvSpPr txBox="1"/>
          <p:nvPr/>
        </p:nvSpPr>
        <p:spPr>
          <a:xfrm>
            <a:off x="6334100" y="3819520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文本框 38">
            <a:extLst>
              <a:ext uri="{FF2B5EF4-FFF2-40B4-BE49-F238E27FC236}">
                <a16:creationId xmlns:a16="http://schemas.microsoft.com/office/drawing/2014/main" xmlns="" id="{4E70E1C2-A499-FBE9-D360-B6A8B01CD65C}"/>
              </a:ext>
            </a:extLst>
          </p:cNvPr>
          <p:cNvSpPr txBox="1"/>
          <p:nvPr/>
        </p:nvSpPr>
        <p:spPr>
          <a:xfrm>
            <a:off x="6337379" y="3668430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2" name="直接连接符 101">
            <a:extLst>
              <a:ext uri="{FF2B5EF4-FFF2-40B4-BE49-F238E27FC236}">
                <a16:creationId xmlns:a16="http://schemas.microsoft.com/office/drawing/2014/main" xmlns="" id="{11733133-141E-EC39-7564-F581169F48AE}"/>
              </a:ext>
            </a:extLst>
          </p:cNvPr>
          <p:cNvCxnSpPr>
            <a:cxnSpLocks/>
          </p:cNvCxnSpPr>
          <p:nvPr/>
        </p:nvCxnSpPr>
        <p:spPr>
          <a:xfrm>
            <a:off x="6667541" y="3692562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xmlns="" id="{A1D0D14E-7519-713F-33D9-4CA79B1DE307}"/>
              </a:ext>
            </a:extLst>
          </p:cNvPr>
          <p:cNvCxnSpPr>
            <a:cxnSpLocks/>
          </p:cNvCxnSpPr>
          <p:nvPr/>
        </p:nvCxnSpPr>
        <p:spPr>
          <a:xfrm>
            <a:off x="6667541" y="3802796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直接连接符 103">
            <a:extLst>
              <a:ext uri="{FF2B5EF4-FFF2-40B4-BE49-F238E27FC236}">
                <a16:creationId xmlns:a16="http://schemas.microsoft.com/office/drawing/2014/main" xmlns="" id="{F41C4A71-AFB2-15A7-7988-30316858D0E3}"/>
              </a:ext>
            </a:extLst>
          </p:cNvPr>
          <p:cNvCxnSpPr>
            <a:cxnSpLocks/>
          </p:cNvCxnSpPr>
          <p:nvPr/>
        </p:nvCxnSpPr>
        <p:spPr>
          <a:xfrm>
            <a:off x="6667541" y="3962697"/>
            <a:ext cx="1746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F5B68885-F885-88CF-6D5A-2962AA6DA21F}"/>
              </a:ext>
            </a:extLst>
          </p:cNvPr>
          <p:cNvPicPr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6354"/>
          <a:stretch/>
        </p:blipFill>
        <p:spPr>
          <a:xfrm>
            <a:off x="4389055" y="1957456"/>
            <a:ext cx="1803600" cy="453600"/>
          </a:xfrm>
          <a:prstGeom prst="rect">
            <a:avLst/>
          </a:prstGeom>
        </p:spPr>
      </p:pic>
      <p:sp>
        <p:nvSpPr>
          <p:cNvPr id="18" name="文本框 1">
            <a:extLst>
              <a:ext uri="{FF2B5EF4-FFF2-40B4-BE49-F238E27FC236}">
                <a16:creationId xmlns:a16="http://schemas.microsoft.com/office/drawing/2014/main" xmlns="" id="{63C8FE70-884D-11B5-D6B0-D6972D42A1B5}"/>
              </a:ext>
            </a:extLst>
          </p:cNvPr>
          <p:cNvSpPr txBox="1"/>
          <p:nvPr/>
        </p:nvSpPr>
        <p:spPr>
          <a:xfrm>
            <a:off x="6337360" y="2082428"/>
            <a:ext cx="526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5983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139</Words>
  <Application>Microsoft Office PowerPoint</Application>
  <PresentationFormat>全屏显示(4:3)</PresentationFormat>
  <Paragraphs>86</Paragraphs>
  <Slides>5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USER</cp:lastModifiedBy>
  <cp:revision>11</cp:revision>
  <dcterms:created xsi:type="dcterms:W3CDTF">2022-10-11T01:29:05Z</dcterms:created>
  <dcterms:modified xsi:type="dcterms:W3CDTF">2022-11-09T07:36:58Z</dcterms:modified>
</cp:coreProperties>
</file>